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02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58005204638573"/>
          <c:y val="0.1642793162452201"/>
          <c:w val="0.73705220070685717"/>
          <c:h val="0.7113691088017623"/>
        </c:manualLayout>
      </c:layout>
      <c:barChart>
        <c:barDir val="col"/>
        <c:grouping val="clustered"/>
        <c:varyColors val="0"/>
        <c:ser>
          <c:idx val="2"/>
          <c:order val="0"/>
          <c:tx>
            <c:v>Metafer with Cyto-B</c:v>
          </c:tx>
          <c:spPr>
            <a:solidFill>
              <a:schemeClr val="accent3">
                <a:lumMod val="60000"/>
                <a:lumOff val="40000"/>
              </a:schemeClr>
            </a:solidFill>
            <a:ln w="19050">
              <a:noFill/>
            </a:ln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1.399090745246066E-3"/>
                  <c:y val="-5.6042021219480265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solidFill>
                          <a:srgbClr val="FF0000"/>
                        </a:solidFill>
                      </a:rPr>
                      <a:t>*</a:t>
                    </a:r>
                    <a:endParaRPr 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1.399090745246066E-3"/>
                  <c:y val="-6.7717442306871989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solidFill>
                          <a:srgbClr val="FF0000"/>
                        </a:solidFill>
                      </a:rPr>
                      <a:t>*</a:t>
                    </a:r>
                    <a:endParaRPr 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Triplicate '!$F$9:$F$14</c:f>
                <c:numCache>
                  <c:formatCode>General</c:formatCode>
                  <c:ptCount val="6"/>
                  <c:pt idx="0">
                    <c:v>0.12414365152245448</c:v>
                  </c:pt>
                  <c:pt idx="1">
                    <c:v>6.5985051070694078E-2</c:v>
                  </c:pt>
                  <c:pt idx="2">
                    <c:v>0.21860642719968865</c:v>
                  </c:pt>
                  <c:pt idx="3">
                    <c:v>0.35283996844129023</c:v>
                  </c:pt>
                  <c:pt idx="4">
                    <c:v>0.38175603978631628</c:v>
                  </c:pt>
                  <c:pt idx="5">
                    <c:v>0.46755431705788653</c:v>
                  </c:pt>
                </c:numCache>
              </c:numRef>
            </c:plus>
            <c:minus>
              <c:numRef>
                <c:f>'Triplicate '!$F$9:$F$14</c:f>
                <c:numCache>
                  <c:formatCode>General</c:formatCode>
                  <c:ptCount val="6"/>
                  <c:pt idx="0">
                    <c:v>0.12414365152245448</c:v>
                  </c:pt>
                  <c:pt idx="1">
                    <c:v>6.5985051070694078E-2</c:v>
                  </c:pt>
                  <c:pt idx="2">
                    <c:v>0.21860642719968865</c:v>
                  </c:pt>
                  <c:pt idx="3">
                    <c:v>0.35283996844129023</c:v>
                  </c:pt>
                  <c:pt idx="4">
                    <c:v>0.38175603978631628</c:v>
                  </c:pt>
                  <c:pt idx="5">
                    <c:v>0.46755431705788653</c:v>
                  </c:pt>
                </c:numCache>
              </c:numRef>
            </c:minus>
          </c:errBars>
          <c:cat>
            <c:numRef>
              <c:f>'Triplicate '!$B$9:$B$14</c:f>
              <c:numCache>
                <c:formatCode>General</c:formatCode>
                <c:ptCount val="6"/>
                <c:pt idx="0">
                  <c:v>0</c:v>
                </c:pt>
                <c:pt idx="1">
                  <c:v>0.312</c:v>
                </c:pt>
                <c:pt idx="2">
                  <c:v>0.625</c:v>
                </c:pt>
                <c:pt idx="3">
                  <c:v>1.25</c:v>
                </c:pt>
                <c:pt idx="4">
                  <c:v>2.5</c:v>
                </c:pt>
                <c:pt idx="5">
                  <c:v>5</c:v>
                </c:pt>
              </c:numCache>
            </c:numRef>
          </c:cat>
          <c:val>
            <c:numRef>
              <c:f>'Triplicate '!$E$9:$E$14</c:f>
              <c:numCache>
                <c:formatCode>General</c:formatCode>
                <c:ptCount val="6"/>
                <c:pt idx="0">
                  <c:v>0.88687823225131368</c:v>
                </c:pt>
                <c:pt idx="1">
                  <c:v>1.0954350417899033</c:v>
                </c:pt>
                <c:pt idx="2">
                  <c:v>1.2277082842104559</c:v>
                </c:pt>
                <c:pt idx="3">
                  <c:v>1.314841486636011</c:v>
                </c:pt>
                <c:pt idx="4">
                  <c:v>1.6356094182640599</c:v>
                </c:pt>
                <c:pt idx="5">
                  <c:v>2.0598241894944525</c:v>
                </c:pt>
              </c:numCache>
            </c:numRef>
          </c:val>
        </c:ser>
        <c:ser>
          <c:idx val="1"/>
          <c:order val="1"/>
          <c:tx>
            <c:v>Metafer without Cyto-B</c:v>
          </c:tx>
          <c:spPr>
            <a:solidFill>
              <a:schemeClr val="bg1">
                <a:lumMod val="75000"/>
              </a:schemeClr>
            </a:solidFill>
            <a:ln w="28575">
              <a:noFill/>
            </a:ln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-1.4431429318591353E-3"/>
                  <c:y val="-0.11208404243896053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solidFill>
                          <a:srgbClr val="FF0000"/>
                        </a:solidFill>
                      </a:rPr>
                      <a:t>*</a:t>
                    </a:r>
                    <a:endParaRPr 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2.8422212451423559E-3"/>
                  <c:y val="-8.6398116046698739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solidFill>
                          <a:srgbClr val="FF0000"/>
                        </a:solidFill>
                      </a:rPr>
                      <a:t>*</a:t>
                    </a:r>
                    <a:endParaRPr 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Triplicate '!$H$9:$H$14</c:f>
                <c:numCache>
                  <c:formatCode>General</c:formatCode>
                  <c:ptCount val="6"/>
                  <c:pt idx="0">
                    <c:v>0.22022062608506721</c:v>
                  </c:pt>
                  <c:pt idx="1">
                    <c:v>0.20657410208176558</c:v>
                  </c:pt>
                  <c:pt idx="2">
                    <c:v>0.31976403052343555</c:v>
                  </c:pt>
                  <c:pt idx="3">
                    <c:v>0.16132172540773482</c:v>
                  </c:pt>
                  <c:pt idx="4">
                    <c:v>0.55300402418796679</c:v>
                  </c:pt>
                  <c:pt idx="5">
                    <c:v>0.47341291170431871</c:v>
                  </c:pt>
                </c:numCache>
              </c:numRef>
            </c:plus>
            <c:minus>
              <c:numRef>
                <c:f>'Triplicate '!$H$9:$H$14</c:f>
                <c:numCache>
                  <c:formatCode>General</c:formatCode>
                  <c:ptCount val="6"/>
                  <c:pt idx="0">
                    <c:v>0.22022062608506721</c:v>
                  </c:pt>
                  <c:pt idx="1">
                    <c:v>0.20657410208176558</c:v>
                  </c:pt>
                  <c:pt idx="2">
                    <c:v>0.31976403052343555</c:v>
                  </c:pt>
                  <c:pt idx="3">
                    <c:v>0.16132172540773482</c:v>
                  </c:pt>
                  <c:pt idx="4">
                    <c:v>0.55300402418796679</c:v>
                  </c:pt>
                  <c:pt idx="5">
                    <c:v>0.47341291170431871</c:v>
                  </c:pt>
                </c:numCache>
              </c:numRef>
            </c:minus>
          </c:errBars>
          <c:cat>
            <c:numRef>
              <c:f>'Triplicate '!$B$9:$B$14</c:f>
              <c:numCache>
                <c:formatCode>General</c:formatCode>
                <c:ptCount val="6"/>
                <c:pt idx="0">
                  <c:v>0</c:v>
                </c:pt>
                <c:pt idx="1">
                  <c:v>0.312</c:v>
                </c:pt>
                <c:pt idx="2">
                  <c:v>0.625</c:v>
                </c:pt>
                <c:pt idx="3">
                  <c:v>1.25</c:v>
                </c:pt>
                <c:pt idx="4">
                  <c:v>2.5</c:v>
                </c:pt>
                <c:pt idx="5">
                  <c:v>5</c:v>
                </c:pt>
              </c:numCache>
            </c:numRef>
          </c:cat>
          <c:val>
            <c:numRef>
              <c:f>'Triplicate '!$G$9:$G$14</c:f>
              <c:numCache>
                <c:formatCode>General</c:formatCode>
                <c:ptCount val="6"/>
                <c:pt idx="0">
                  <c:v>0.71306949344562509</c:v>
                </c:pt>
                <c:pt idx="1">
                  <c:v>0.92490819834879878</c:v>
                </c:pt>
                <c:pt idx="2">
                  <c:v>0.86280721373023905</c:v>
                </c:pt>
                <c:pt idx="3">
                  <c:v>1.0916181922929702</c:v>
                </c:pt>
                <c:pt idx="4">
                  <c:v>1.3712053496296606</c:v>
                </c:pt>
                <c:pt idx="5">
                  <c:v>1.9109122052859355</c:v>
                </c:pt>
              </c:numCache>
            </c:numRef>
          </c:val>
        </c:ser>
        <c:ser>
          <c:idx val="0"/>
          <c:order val="2"/>
          <c:tx>
            <c:v>Microflow</c:v>
          </c:tx>
          <c:spPr>
            <a:solidFill>
              <a:schemeClr val="tx1"/>
            </a:solidFill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1.399090745246066E-3"/>
                  <c:y val="-5.1371852784523574E-2"/>
                </c:manualLayout>
              </c:layout>
              <c:tx>
                <c:rich>
                  <a:bodyPr/>
                  <a:lstStyle/>
                  <a:p>
                    <a:r>
                      <a:rPr lang="en-US" sz="1000" dirty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1.3991573533099963E-3"/>
                  <c:y val="-0.14374035643057034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solidFill>
                          <a:srgbClr val="FF0000"/>
                        </a:solidFill>
                      </a:rPr>
                      <a:t>*</a:t>
                    </a:r>
                    <a:endParaRPr 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Triplicate '!$D$9:$D$15</c:f>
                <c:numCache>
                  <c:formatCode>General</c:formatCode>
                  <c:ptCount val="7"/>
                  <c:pt idx="0">
                    <c:v>7.817028432407841E-2</c:v>
                  </c:pt>
                  <c:pt idx="1">
                    <c:v>0.14024703704275701</c:v>
                  </c:pt>
                  <c:pt idx="2">
                    <c:v>0.13653880267283589</c:v>
                  </c:pt>
                  <c:pt idx="3">
                    <c:v>0.42340887912996211</c:v>
                  </c:pt>
                  <c:pt idx="4">
                    <c:v>0.31331086637259692</c:v>
                  </c:pt>
                  <c:pt idx="5">
                    <c:v>0.86926546201143862</c:v>
                  </c:pt>
                </c:numCache>
              </c:numRef>
            </c:plus>
            <c:minus>
              <c:numRef>
                <c:f>'Triplicate '!$D$9:$D$15</c:f>
                <c:numCache>
                  <c:formatCode>General</c:formatCode>
                  <c:ptCount val="7"/>
                  <c:pt idx="0">
                    <c:v>7.817028432407841E-2</c:v>
                  </c:pt>
                  <c:pt idx="1">
                    <c:v>0.14024703704275701</c:v>
                  </c:pt>
                  <c:pt idx="2">
                    <c:v>0.13653880267283589</c:v>
                  </c:pt>
                  <c:pt idx="3">
                    <c:v>0.42340887912996211</c:v>
                  </c:pt>
                  <c:pt idx="4">
                    <c:v>0.31331086637259692</c:v>
                  </c:pt>
                  <c:pt idx="5">
                    <c:v>0.86926546201143862</c:v>
                  </c:pt>
                </c:numCache>
              </c:numRef>
            </c:minus>
          </c:errBars>
          <c:cat>
            <c:numRef>
              <c:f>'Triplicate '!$B$9:$B$14</c:f>
              <c:numCache>
                <c:formatCode>General</c:formatCode>
                <c:ptCount val="6"/>
                <c:pt idx="0">
                  <c:v>0</c:v>
                </c:pt>
                <c:pt idx="1">
                  <c:v>0.312</c:v>
                </c:pt>
                <c:pt idx="2">
                  <c:v>0.625</c:v>
                </c:pt>
                <c:pt idx="3">
                  <c:v>1.25</c:v>
                </c:pt>
                <c:pt idx="4">
                  <c:v>2.5</c:v>
                </c:pt>
                <c:pt idx="5">
                  <c:v>5</c:v>
                </c:pt>
              </c:numCache>
            </c:numRef>
          </c:cat>
          <c:val>
            <c:numRef>
              <c:f>'Triplicate '!$C$9:$C$14</c:f>
              <c:numCache>
                <c:formatCode>General</c:formatCode>
                <c:ptCount val="6"/>
                <c:pt idx="0">
                  <c:v>0.52288615565127616</c:v>
                </c:pt>
                <c:pt idx="1">
                  <c:v>0.51014369354266409</c:v>
                </c:pt>
                <c:pt idx="2">
                  <c:v>0.81950974837319601</c:v>
                </c:pt>
                <c:pt idx="3">
                  <c:v>1.1558901747715156</c:v>
                </c:pt>
                <c:pt idx="4">
                  <c:v>1.5513288712875457</c:v>
                </c:pt>
                <c:pt idx="5">
                  <c:v>2.84503672155114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250304"/>
        <c:axId val="138276864"/>
      </c:barChart>
      <c:lineChart>
        <c:grouping val="standard"/>
        <c:varyColors val="0"/>
        <c:ser>
          <c:idx val="4"/>
          <c:order val="3"/>
          <c:tx>
            <c:v>% RPD</c:v>
          </c:tx>
          <c:spPr>
            <a:ln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Triplicate '!$K$9:$K$1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9521547934583801</c:v>
                  </c:pt>
                  <c:pt idx="2">
                    <c:v>4.3504591570892455</c:v>
                  </c:pt>
                  <c:pt idx="3">
                    <c:v>3.8372529844822636</c:v>
                  </c:pt>
                  <c:pt idx="4">
                    <c:v>8.1990442615359154</c:v>
                  </c:pt>
                  <c:pt idx="5">
                    <c:v>4.1631702463480558</c:v>
                  </c:pt>
                </c:numCache>
              </c:numRef>
            </c:plus>
            <c:minus>
              <c:numRef>
                <c:f>'Triplicate '!$K$9:$K$1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9521547934583801</c:v>
                  </c:pt>
                  <c:pt idx="2">
                    <c:v>4.3504591570892455</c:v>
                  </c:pt>
                  <c:pt idx="3">
                    <c:v>3.8372529844822636</c:v>
                  </c:pt>
                  <c:pt idx="4">
                    <c:v>8.1990442615359154</c:v>
                  </c:pt>
                  <c:pt idx="5">
                    <c:v>4.1631702463480558</c:v>
                  </c:pt>
                </c:numCache>
              </c:numRef>
            </c:minus>
          </c:errBars>
          <c:val>
            <c:numRef>
              <c:f>'Triplicate '!$J$9:$J$14</c:f>
              <c:numCache>
                <c:formatCode>General</c:formatCode>
                <c:ptCount val="6"/>
                <c:pt idx="0">
                  <c:v>100</c:v>
                </c:pt>
                <c:pt idx="1">
                  <c:v>95.613471602713531</c:v>
                </c:pt>
                <c:pt idx="2">
                  <c:v>87.967055481690025</c:v>
                </c:pt>
                <c:pt idx="3">
                  <c:v>76.820003031576363</c:v>
                </c:pt>
                <c:pt idx="4">
                  <c:v>70.697717267439742</c:v>
                </c:pt>
                <c:pt idx="5">
                  <c:v>56.79628591481844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904896"/>
        <c:axId val="138279168"/>
      </c:lineChart>
      <c:catAx>
        <c:axId val="1372503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MMS (µg/ml)</a:t>
                </a:r>
              </a:p>
            </c:rich>
          </c:tx>
          <c:layout>
            <c:manualLayout>
              <c:xMode val="edge"/>
              <c:yMode val="edge"/>
              <c:x val="0.38264349713638074"/>
              <c:y val="0.9361984082815202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38276864"/>
        <c:crosses val="autoZero"/>
        <c:auto val="1"/>
        <c:lblAlgn val="ctr"/>
        <c:lblOffset val="100"/>
        <c:noMultiLvlLbl val="0"/>
      </c:catAx>
      <c:valAx>
        <c:axId val="1382768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% Micronuclei </a:t>
                </a:r>
              </a:p>
            </c:rich>
          </c:tx>
          <c:layout>
            <c:manualLayout>
              <c:xMode val="edge"/>
              <c:yMode val="edge"/>
              <c:x val="4.3089116374136031E-3"/>
              <c:y val="0.398118150195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37250304"/>
        <c:crosses val="autoZero"/>
        <c:crossBetween val="between"/>
      </c:valAx>
      <c:valAx>
        <c:axId val="138279168"/>
        <c:scaling>
          <c:orientation val="minMax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% Relative Population Doubling</a:t>
                </a:r>
              </a:p>
            </c:rich>
          </c:tx>
          <c:layout>
            <c:manualLayout>
              <c:xMode val="edge"/>
              <c:yMode val="edge"/>
              <c:x val="0.93523525817985043"/>
              <c:y val="0.2435604231909607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9904896"/>
        <c:crosses val="max"/>
        <c:crossBetween val="between"/>
      </c:valAx>
      <c:catAx>
        <c:axId val="139904896"/>
        <c:scaling>
          <c:orientation val="minMax"/>
        </c:scaling>
        <c:delete val="1"/>
        <c:axPos val="b"/>
        <c:majorTickMark val="out"/>
        <c:minorTickMark val="none"/>
        <c:tickLblPos val="nextTo"/>
        <c:crossAx val="138279168"/>
        <c:crosses val="autoZero"/>
        <c:auto val="1"/>
        <c:lblAlgn val="ctr"/>
        <c:lblOffset val="100"/>
        <c:noMultiLvlLbl val="0"/>
      </c:catAx>
      <c:spPr>
        <a:solidFill>
          <a:sysClr val="window" lastClr="FFFFFF"/>
        </a:solidFill>
        <a:ln w="25400">
          <a:noFill/>
        </a:ln>
      </c:spPr>
    </c:plotArea>
    <c:legend>
      <c:legendPos val="t"/>
      <c:layout>
        <c:manualLayout>
          <c:xMode val="edge"/>
          <c:yMode val="edge"/>
          <c:x val="0"/>
          <c:y val="1.4569619958539873E-3"/>
          <c:w val="0.97932942487143182"/>
          <c:h val="0.13489080480913837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>
      <a:solidFill>
        <a:schemeClr val="tx1">
          <a:lumMod val="95000"/>
          <a:lumOff val="5000"/>
        </a:schemeClr>
      </a:solidFill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50361706048231"/>
          <c:y val="0.16263513513513511"/>
          <c:w val="0.73041213768115942"/>
          <c:h val="0.67579767267267266"/>
        </c:manualLayout>
      </c:layout>
      <c:barChart>
        <c:barDir val="col"/>
        <c:grouping val="clustered"/>
        <c:varyColors val="0"/>
        <c:ser>
          <c:idx val="1"/>
          <c:order val="0"/>
          <c:tx>
            <c:v>Metafer with cyto-B</c:v>
          </c:tx>
          <c:spPr>
            <a:solidFill>
              <a:schemeClr val="accent3">
                <a:lumMod val="60000"/>
                <a:lumOff val="40000"/>
              </a:schemeClr>
            </a:solidFill>
          </c:spPr>
          <c:invertIfNegative val="0"/>
          <c:dLbls>
            <c:dLbl>
              <c:idx val="5"/>
              <c:layout/>
              <c:tx>
                <c:rich>
                  <a:bodyPr wrap="square" lIns="38100" tIns="19050" rIns="38100" bIns="19050" anchor="ctr">
                    <a:spAutoFit/>
                  </a:bodyPr>
                  <a:lstStyle/>
                  <a:p>
                    <a:pPr>
                      <a:defRPr sz="1000">
                        <a:solidFill>
                          <a:srgbClr val="FF0000"/>
                        </a:solidFill>
                      </a:defRPr>
                    </a:pPr>
                    <a:r>
                      <a:rPr lang="en-US" sz="1000" dirty="0" smtClean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>
                      <a:solidFill>
                        <a:srgbClr val="FF0000"/>
                      </a:solidFill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/>
              <c:tx>
                <c:rich>
                  <a:bodyPr wrap="square" lIns="38100" tIns="19050" rIns="38100" bIns="19050" anchor="ctr">
                    <a:spAutoFit/>
                  </a:bodyPr>
                  <a:lstStyle/>
                  <a:p>
                    <a:pPr>
                      <a:defRPr sz="1000">
                        <a:solidFill>
                          <a:srgbClr val="FF0000"/>
                        </a:solidFill>
                      </a:defRPr>
                    </a:pPr>
                    <a:r>
                      <a:rPr lang="en-US" sz="1000" dirty="0" smtClean="0">
                        <a:solidFill>
                          <a:srgbClr val="FF0000"/>
                        </a:solidFill>
                      </a:rPr>
                      <a:t>*</a:t>
                    </a:r>
                  </a:p>
                  <a:p>
                    <a:pPr>
                      <a:defRPr sz="1000">
                        <a:solidFill>
                          <a:srgbClr val="FF0000"/>
                        </a:solidFill>
                      </a:defRPr>
                    </a:pPr>
                    <a:endParaRPr lang="en-US" sz="1000" dirty="0">
                      <a:solidFill>
                        <a:srgbClr val="FF0000"/>
                      </a:solidFill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errBars>
            <c:errBarType val="both"/>
            <c:errValType val="cust"/>
            <c:noEndCap val="0"/>
            <c:plus>
              <c:numRef>
                <c:f>'Triplicate data'!$L$4:$L$10</c:f>
                <c:numCache>
                  <c:formatCode>General</c:formatCode>
                  <c:ptCount val="7"/>
                  <c:pt idx="0">
                    <c:v>0.17918156322249112</c:v>
                  </c:pt>
                  <c:pt idx="1">
                    <c:v>6.2878564447768362E-2</c:v>
                  </c:pt>
                  <c:pt idx="2">
                    <c:v>6.00564046549147E-2</c:v>
                  </c:pt>
                  <c:pt idx="3">
                    <c:v>1.6083963071382144E-3</c:v>
                  </c:pt>
                  <c:pt idx="4">
                    <c:v>0.11445073505895517</c:v>
                  </c:pt>
                  <c:pt idx="5">
                    <c:v>0.3930138301345657</c:v>
                  </c:pt>
                  <c:pt idx="6">
                    <c:v>0.5773247479965955</c:v>
                  </c:pt>
                </c:numCache>
              </c:numRef>
            </c:plus>
            <c:minus>
              <c:numRef>
                <c:f>'Triplicate data'!$L$4:$L$10</c:f>
                <c:numCache>
                  <c:formatCode>General</c:formatCode>
                  <c:ptCount val="7"/>
                  <c:pt idx="0">
                    <c:v>0.17918156322249112</c:v>
                  </c:pt>
                  <c:pt idx="1">
                    <c:v>6.2878564447768362E-2</c:v>
                  </c:pt>
                  <c:pt idx="2">
                    <c:v>6.00564046549147E-2</c:v>
                  </c:pt>
                  <c:pt idx="3">
                    <c:v>1.6083963071382144E-3</c:v>
                  </c:pt>
                  <c:pt idx="4">
                    <c:v>0.11445073505895517</c:v>
                  </c:pt>
                  <c:pt idx="5">
                    <c:v>0.3930138301345657</c:v>
                  </c:pt>
                  <c:pt idx="6">
                    <c:v>0.5773247479965955</c:v>
                  </c:pt>
                </c:numCache>
              </c:numRef>
            </c:minus>
          </c:errBars>
          <c:val>
            <c:numRef>
              <c:f>'Triplicate data'!$K$4:$K$10</c:f>
              <c:numCache>
                <c:formatCode>General</c:formatCode>
                <c:ptCount val="7"/>
                <c:pt idx="0">
                  <c:v>0.86180546693136639</c:v>
                </c:pt>
                <c:pt idx="1">
                  <c:v>0.82294415838735013</c:v>
                </c:pt>
                <c:pt idx="2">
                  <c:v>0.69194476794467119</c:v>
                </c:pt>
                <c:pt idx="3">
                  <c:v>0.66523320390076657</c:v>
                </c:pt>
                <c:pt idx="4">
                  <c:v>0.93032296011018289</c:v>
                </c:pt>
                <c:pt idx="5">
                  <c:v>1.2482403667251905</c:v>
                </c:pt>
                <c:pt idx="6">
                  <c:v>1.2895480657006133</c:v>
                </c:pt>
              </c:numCache>
            </c:numRef>
          </c:val>
        </c:ser>
        <c:ser>
          <c:idx val="0"/>
          <c:order val="1"/>
          <c:tx>
            <c:v>Metafer without cyto-B</c:v>
          </c:tx>
          <c:spPr>
            <a:solidFill>
              <a:schemeClr val="bg1">
                <a:lumMod val="75000"/>
              </a:schemeClr>
            </a:solidFill>
            <a:ln w="19050">
              <a:solidFill>
                <a:schemeClr val="bg1">
                  <a:lumMod val="75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sz="1000" dirty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sz="1000" dirty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000"/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Triplicate data'!$F$4:$F$10</c:f>
                <c:numCache>
                  <c:formatCode>General</c:formatCode>
                  <c:ptCount val="7"/>
                  <c:pt idx="0">
                    <c:v>0.22912526646715442</c:v>
                  </c:pt>
                  <c:pt idx="1">
                    <c:v>0.32013877481142977</c:v>
                  </c:pt>
                  <c:pt idx="2">
                    <c:v>8.990566104931362E-2</c:v>
                  </c:pt>
                  <c:pt idx="3">
                    <c:v>4.351536674514473E-2</c:v>
                  </c:pt>
                  <c:pt idx="4">
                    <c:v>0.20102076843782685</c:v>
                  </c:pt>
                  <c:pt idx="5">
                    <c:v>0.14178021133627466</c:v>
                  </c:pt>
                  <c:pt idx="6">
                    <c:v>0.17332119783431277</c:v>
                  </c:pt>
                </c:numCache>
              </c:numRef>
            </c:plus>
            <c:minus>
              <c:numRef>
                <c:f>'Triplicate data'!$F$4:$F$10</c:f>
                <c:numCache>
                  <c:formatCode>General</c:formatCode>
                  <c:ptCount val="7"/>
                  <c:pt idx="0">
                    <c:v>0.22912526646715442</c:v>
                  </c:pt>
                  <c:pt idx="1">
                    <c:v>0.32013877481142977</c:v>
                  </c:pt>
                  <c:pt idx="2">
                    <c:v>8.990566104931362E-2</c:v>
                  </c:pt>
                  <c:pt idx="3">
                    <c:v>4.351536674514473E-2</c:v>
                  </c:pt>
                  <c:pt idx="4">
                    <c:v>0.20102076843782685</c:v>
                  </c:pt>
                  <c:pt idx="5">
                    <c:v>0.14178021133627466</c:v>
                  </c:pt>
                  <c:pt idx="6">
                    <c:v>0.17332119783431277</c:v>
                  </c:pt>
                </c:numCache>
              </c:numRef>
            </c:minus>
          </c:errBars>
          <c:cat>
            <c:numRef>
              <c:f>'Triplicate data'!$A$4:$A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  <c:pt idx="4">
                  <c:v>0.8</c:v>
                </c:pt>
                <c:pt idx="5">
                  <c:v>1</c:v>
                </c:pt>
                <c:pt idx="6">
                  <c:v>1.6</c:v>
                </c:pt>
              </c:numCache>
            </c:numRef>
          </c:cat>
          <c:val>
            <c:numRef>
              <c:f>'Triplicate data'!$E$4:$E$10</c:f>
              <c:numCache>
                <c:formatCode>General</c:formatCode>
                <c:ptCount val="7"/>
                <c:pt idx="0">
                  <c:v>0.46233385733263854</c:v>
                </c:pt>
                <c:pt idx="1">
                  <c:v>0.46014842638323539</c:v>
                </c:pt>
                <c:pt idx="2">
                  <c:v>0.34607434103097795</c:v>
                </c:pt>
                <c:pt idx="3">
                  <c:v>0.29717298080429105</c:v>
                </c:pt>
                <c:pt idx="4">
                  <c:v>0.76010798845500682</c:v>
                </c:pt>
                <c:pt idx="5">
                  <c:v>0.87715008265317096</c:v>
                </c:pt>
                <c:pt idx="6">
                  <c:v>1.0155596575864443</c:v>
                </c:pt>
              </c:numCache>
            </c:numRef>
          </c:val>
        </c:ser>
        <c:ser>
          <c:idx val="2"/>
          <c:order val="2"/>
          <c:tx>
            <c:v>MicroFlow</c:v>
          </c:tx>
          <c:spPr>
            <a:solidFill>
              <a:schemeClr val="tx1"/>
            </a:solidFill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1.0959503684636917E-3"/>
                  <c:y val="-5.4644800034931877E-2"/>
                </c:manualLayout>
              </c:layout>
              <c:tx>
                <c:rich>
                  <a:bodyPr/>
                  <a:lstStyle/>
                  <a:p>
                    <a:r>
                      <a:rPr lang="en-US" sz="1000" dirty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1.0959503684636917E-3"/>
                  <c:y val="-0.11536124451818952"/>
                </c:manualLayout>
              </c:layout>
              <c:tx>
                <c:rich>
                  <a:bodyPr/>
                  <a:lstStyle/>
                  <a:p>
                    <a:r>
                      <a:rPr lang="en-US" sz="1000" dirty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0"/>
                  <c:y val="-3.8453748172729799E-2"/>
                </c:manualLayout>
              </c:layout>
              <c:tx>
                <c:rich>
                  <a:bodyPr/>
                  <a:lstStyle/>
                  <a:p>
                    <a:r>
                      <a:rPr lang="en-US" sz="1000" dirty="0" smtClean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Triplicate data'!$R$4:$R$10</c:f>
                <c:numCache>
                  <c:formatCode>General</c:formatCode>
                  <c:ptCount val="7"/>
                  <c:pt idx="0">
                    <c:v>2.373840200703823E-2</c:v>
                  </c:pt>
                  <c:pt idx="1">
                    <c:v>4.590993377180539E-2</c:v>
                  </c:pt>
                  <c:pt idx="2">
                    <c:v>3.7707098831347936E-2</c:v>
                  </c:pt>
                  <c:pt idx="3">
                    <c:v>0.10736852878127817</c:v>
                  </c:pt>
                  <c:pt idx="4">
                    <c:v>0.73140876005274458</c:v>
                  </c:pt>
                  <c:pt idx="5">
                    <c:v>1.5135152997053243</c:v>
                  </c:pt>
                  <c:pt idx="6">
                    <c:v>0.57133076373751968</c:v>
                  </c:pt>
                </c:numCache>
              </c:numRef>
            </c:plus>
            <c:minus>
              <c:numRef>
                <c:f>'Triplicate data'!$R$4:$R$10</c:f>
                <c:numCache>
                  <c:formatCode>General</c:formatCode>
                  <c:ptCount val="7"/>
                  <c:pt idx="0">
                    <c:v>2.373840200703823E-2</c:v>
                  </c:pt>
                  <c:pt idx="1">
                    <c:v>4.590993377180539E-2</c:v>
                  </c:pt>
                  <c:pt idx="2">
                    <c:v>3.7707098831347936E-2</c:v>
                  </c:pt>
                  <c:pt idx="3">
                    <c:v>0.10736852878127817</c:v>
                  </c:pt>
                  <c:pt idx="4">
                    <c:v>0.73140876005274458</c:v>
                  </c:pt>
                  <c:pt idx="5">
                    <c:v>1.5135152997053243</c:v>
                  </c:pt>
                  <c:pt idx="6">
                    <c:v>0.57133076373751968</c:v>
                  </c:pt>
                </c:numCache>
              </c:numRef>
            </c:minus>
          </c:errBars>
          <c:cat>
            <c:numRef>
              <c:f>'Triplicate data'!$A$4:$A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2</c:v>
                </c:pt>
                <c:pt idx="3">
                  <c:v>0.4</c:v>
                </c:pt>
                <c:pt idx="4">
                  <c:v>0.8</c:v>
                </c:pt>
                <c:pt idx="5">
                  <c:v>1</c:v>
                </c:pt>
                <c:pt idx="6">
                  <c:v>1.6</c:v>
                </c:pt>
              </c:numCache>
            </c:numRef>
          </c:cat>
          <c:val>
            <c:numRef>
              <c:f>'Triplicate data'!$Q$4:$Q$10</c:f>
              <c:numCache>
                <c:formatCode>General</c:formatCode>
                <c:ptCount val="7"/>
                <c:pt idx="0">
                  <c:v>0.37866598433656845</c:v>
                </c:pt>
                <c:pt idx="1">
                  <c:v>0.30122430189491811</c:v>
                </c:pt>
                <c:pt idx="2">
                  <c:v>0.36006591594672988</c:v>
                </c:pt>
                <c:pt idx="3">
                  <c:v>0.37918216133384197</c:v>
                </c:pt>
                <c:pt idx="4">
                  <c:v>2.0653275029905069</c:v>
                </c:pt>
                <c:pt idx="5">
                  <c:v>3.1049037435059716</c:v>
                </c:pt>
                <c:pt idx="6">
                  <c:v>5.49611552061964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9022720"/>
        <c:axId val="119024640"/>
      </c:barChart>
      <c:lineChart>
        <c:grouping val="standard"/>
        <c:varyColors val="0"/>
        <c:ser>
          <c:idx val="3"/>
          <c:order val="3"/>
          <c:tx>
            <c:v>%RPD</c:v>
          </c:tx>
          <c:spPr>
            <a:ln w="28575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riplicate data'!$V$20:$V$2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5.3483336554272451</c:v>
                  </c:pt>
                  <c:pt idx="2">
                    <c:v>3.3157875437280659</c:v>
                  </c:pt>
                  <c:pt idx="3">
                    <c:v>4.6638701674281435</c:v>
                  </c:pt>
                  <c:pt idx="4">
                    <c:v>3.3508926091624476</c:v>
                  </c:pt>
                  <c:pt idx="5">
                    <c:v>5.0223229687036444</c:v>
                  </c:pt>
                  <c:pt idx="6">
                    <c:v>3.0100720401043768</c:v>
                  </c:pt>
                </c:numCache>
              </c:numRef>
            </c:plus>
            <c:minus>
              <c:numRef>
                <c:f>'Triplicate data'!$V$20:$V$2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5.3483336554272451</c:v>
                  </c:pt>
                  <c:pt idx="2">
                    <c:v>3.3157875437280659</c:v>
                  </c:pt>
                  <c:pt idx="3">
                    <c:v>4.6638701674281435</c:v>
                  </c:pt>
                  <c:pt idx="4">
                    <c:v>3.3508926091624476</c:v>
                  </c:pt>
                  <c:pt idx="5">
                    <c:v>5.0223229687036444</c:v>
                  </c:pt>
                  <c:pt idx="6">
                    <c:v>3.0100720401043768</c:v>
                  </c:pt>
                </c:numCache>
              </c:numRef>
            </c:minus>
          </c:errBars>
          <c:val>
            <c:numRef>
              <c:f>'Triplicate data'!$U$20:$U$26</c:f>
              <c:numCache>
                <c:formatCode>General</c:formatCode>
                <c:ptCount val="7"/>
                <c:pt idx="0">
                  <c:v>100</c:v>
                </c:pt>
                <c:pt idx="1">
                  <c:v>102.50197287510485</c:v>
                </c:pt>
                <c:pt idx="2">
                  <c:v>98.755458504252331</c:v>
                </c:pt>
                <c:pt idx="3">
                  <c:v>98.868566823090973</c:v>
                </c:pt>
                <c:pt idx="4">
                  <c:v>76.165787059149167</c:v>
                </c:pt>
                <c:pt idx="5">
                  <c:v>66.730559431172836</c:v>
                </c:pt>
                <c:pt idx="6">
                  <c:v>48.5696462795374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9053312"/>
        <c:axId val="119051392"/>
      </c:lineChart>
      <c:catAx>
        <c:axId val="1190227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Carbendazim (µg/ml)</a:t>
                </a:r>
              </a:p>
            </c:rich>
          </c:tx>
          <c:layout>
            <c:manualLayout>
              <c:xMode val="edge"/>
              <c:yMode val="edge"/>
              <c:x val="0.30460114734299515"/>
              <c:y val="0.9302582582582582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19024640"/>
        <c:crosses val="autoZero"/>
        <c:auto val="1"/>
        <c:lblAlgn val="ctr"/>
        <c:lblOffset val="100"/>
        <c:noMultiLvlLbl val="0"/>
      </c:catAx>
      <c:valAx>
        <c:axId val="1190246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% Micronuclei  </a:t>
                </a:r>
              </a:p>
            </c:rich>
          </c:tx>
          <c:layout>
            <c:manualLayout>
              <c:xMode val="edge"/>
              <c:yMode val="edge"/>
              <c:x val="2.3007246376811594E-2"/>
              <c:y val="0.3558723723723723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19022720"/>
        <c:crosses val="autoZero"/>
        <c:crossBetween val="between"/>
      </c:valAx>
      <c:valAx>
        <c:axId val="119051392"/>
        <c:scaling>
          <c:orientation val="minMax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% Relative Population Doubling</a:t>
                </a:r>
              </a:p>
            </c:rich>
          </c:tx>
          <c:layout>
            <c:manualLayout>
              <c:xMode val="edge"/>
              <c:yMode val="edge"/>
              <c:x val="0.93404861111111115"/>
              <c:y val="0.2198423423423423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19053312"/>
        <c:crosses val="max"/>
        <c:crossBetween val="between"/>
      </c:valAx>
      <c:catAx>
        <c:axId val="119053312"/>
        <c:scaling>
          <c:orientation val="minMax"/>
        </c:scaling>
        <c:delete val="1"/>
        <c:axPos val="b"/>
        <c:majorTickMark val="out"/>
        <c:minorTickMark val="none"/>
        <c:tickLblPos val="nextTo"/>
        <c:crossAx val="119051392"/>
        <c:crosses val="autoZero"/>
        <c:auto val="1"/>
        <c:lblAlgn val="ctr"/>
        <c:lblOffset val="100"/>
        <c:noMultiLvlLbl val="0"/>
      </c:catAx>
    </c:plotArea>
    <c:legend>
      <c:legendPos val="t"/>
      <c:layout>
        <c:manualLayout>
          <c:xMode val="edge"/>
          <c:yMode val="edge"/>
          <c:x val="8.2866545893719806E-2"/>
          <c:y val="1.33063063063063E-2"/>
          <c:w val="0.84963345410628022"/>
          <c:h val="0.12650412912912912"/>
        </c:manualLayout>
      </c:layout>
      <c:overlay val="0"/>
    </c:legend>
    <c:plotVisOnly val="1"/>
    <c:dispBlanksAs val="gap"/>
    <c:showDLblsOverMax val="0"/>
  </c:chart>
  <c:spPr>
    <a:ln>
      <a:solidFill>
        <a:schemeClr val="tx1">
          <a:lumMod val="95000"/>
          <a:lumOff val="5000"/>
        </a:schemeClr>
      </a:solidFill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46618357487921"/>
          <c:y val="0.21543843843843843"/>
          <c:w val="0.76244384057971015"/>
          <c:h val="0.65843543543543548"/>
        </c:manualLayout>
      </c:layout>
      <c:barChart>
        <c:barDir val="col"/>
        <c:grouping val="clustered"/>
        <c:varyColors val="0"/>
        <c:ser>
          <c:idx val="3"/>
          <c:order val="0"/>
          <c:tx>
            <c:v>Metafer with cyto-B</c:v>
          </c:tx>
          <c:spPr>
            <a:solidFill>
              <a:schemeClr val="accent3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Triplicates '!$S$6:$S$9</c:f>
                <c:numCache>
                  <c:formatCode>General</c:formatCode>
                  <c:ptCount val="4"/>
                  <c:pt idx="0">
                    <c:v>0.10745020242181989</c:v>
                  </c:pt>
                  <c:pt idx="1">
                    <c:v>7.5390222440844201E-2</c:v>
                  </c:pt>
                  <c:pt idx="2">
                    <c:v>8.3400416840623562E-2</c:v>
                  </c:pt>
                  <c:pt idx="3">
                    <c:v>0.19997329457647747</c:v>
                  </c:pt>
                </c:numCache>
              </c:numRef>
            </c:plus>
            <c:minus>
              <c:numRef>
                <c:f>'Triplicates '!$S$6:$S$9</c:f>
                <c:numCache>
                  <c:formatCode>General</c:formatCode>
                  <c:ptCount val="4"/>
                  <c:pt idx="0">
                    <c:v>0.10745020242181989</c:v>
                  </c:pt>
                  <c:pt idx="1">
                    <c:v>7.5390222440844201E-2</c:v>
                  </c:pt>
                  <c:pt idx="2">
                    <c:v>8.3400416840623562E-2</c:v>
                  </c:pt>
                  <c:pt idx="3">
                    <c:v>0.19997329457647747</c:v>
                  </c:pt>
                </c:numCache>
              </c:numRef>
            </c:minus>
          </c:errBars>
          <c:val>
            <c:numRef>
              <c:f>'Triplicates '!$R$6:$R$9</c:f>
              <c:numCache>
                <c:formatCode>General</c:formatCode>
                <c:ptCount val="4"/>
                <c:pt idx="0">
                  <c:v>0.4582907489063508</c:v>
                </c:pt>
                <c:pt idx="1">
                  <c:v>0.39173627350781004</c:v>
                </c:pt>
                <c:pt idx="2">
                  <c:v>0.48832497233074407</c:v>
                </c:pt>
                <c:pt idx="3">
                  <c:v>0.43478981915248854</c:v>
                </c:pt>
              </c:numCache>
            </c:numRef>
          </c:val>
        </c:ser>
        <c:ser>
          <c:idx val="0"/>
          <c:order val="1"/>
          <c:tx>
            <c:v>Metafer without cyto-B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Triplicates '!$H$6:$H$9</c:f>
                <c:numCache>
                  <c:formatCode>General</c:formatCode>
                  <c:ptCount val="4"/>
                  <c:pt idx="0">
                    <c:v>9.1267264057931619E-2</c:v>
                  </c:pt>
                  <c:pt idx="1">
                    <c:v>0.12318390452241797</c:v>
                  </c:pt>
                  <c:pt idx="2">
                    <c:v>0.26065634501846979</c:v>
                  </c:pt>
                  <c:pt idx="3">
                    <c:v>0.2135477052387128</c:v>
                  </c:pt>
                </c:numCache>
              </c:numRef>
            </c:plus>
            <c:minus>
              <c:numRef>
                <c:f>'Triplicates '!$H$6:$H$9</c:f>
                <c:numCache>
                  <c:formatCode>General</c:formatCode>
                  <c:ptCount val="4"/>
                  <c:pt idx="0">
                    <c:v>9.1267264057931619E-2</c:v>
                  </c:pt>
                  <c:pt idx="1">
                    <c:v>0.12318390452241797</c:v>
                  </c:pt>
                  <c:pt idx="2">
                    <c:v>0.26065634501846979</c:v>
                  </c:pt>
                  <c:pt idx="3">
                    <c:v>0.2135477052387128</c:v>
                  </c:pt>
                </c:numCache>
              </c:numRef>
            </c:minus>
          </c:errBars>
          <c:cat>
            <c:numRef>
              <c:f>'Triplicates '!$U$5:$U$8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'Triplicates '!$G$6:$G$9</c:f>
              <c:numCache>
                <c:formatCode>General</c:formatCode>
                <c:ptCount val="4"/>
                <c:pt idx="0">
                  <c:v>0.33120237563161919</c:v>
                </c:pt>
                <c:pt idx="1">
                  <c:v>0.18389224522732239</c:v>
                </c:pt>
                <c:pt idx="2">
                  <c:v>0.42974649901168022</c:v>
                </c:pt>
                <c:pt idx="3">
                  <c:v>0.55658280793274206</c:v>
                </c:pt>
              </c:numCache>
            </c:numRef>
          </c:val>
        </c:ser>
        <c:ser>
          <c:idx val="1"/>
          <c:order val="2"/>
          <c:tx>
            <c:v>MicroFlow</c:v>
          </c:tx>
          <c:spPr>
            <a:solidFill>
              <a:schemeClr val="tx1">
                <a:lumMod val="95000"/>
                <a:lumOff val="5000"/>
              </a:schemeClr>
            </a:solidFill>
          </c:spPr>
          <c:invertIfNegative val="0"/>
          <c:dLbls>
            <c:dLbl>
              <c:idx val="3"/>
              <c:layout>
                <c:manualLayout>
                  <c:x val="0"/>
                  <c:y val="-3.3370870870870872E-2"/>
                </c:manualLayout>
              </c:layout>
              <c:tx>
                <c:rich>
                  <a:bodyPr wrap="square" lIns="38100" tIns="19050" rIns="38100" bIns="19050" anchor="ctr">
                    <a:spAutoFit/>
                  </a:bodyPr>
                  <a:lstStyle/>
                  <a:p>
                    <a:pPr>
                      <a:defRPr sz="1000">
                        <a:solidFill>
                          <a:srgbClr val="FF0000"/>
                        </a:solidFill>
                      </a:defRPr>
                    </a:pPr>
                    <a:r>
                      <a:rPr lang="en-US" sz="1000" dirty="0" smtClean="0">
                        <a:solidFill>
                          <a:srgbClr val="FF0000"/>
                        </a:solidFill>
                      </a:rPr>
                      <a:t>*</a:t>
                    </a:r>
                    <a:endParaRPr lang="en-US" sz="1000" dirty="0">
                      <a:solidFill>
                        <a:srgbClr val="FF0000"/>
                      </a:solidFill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errBars>
            <c:errBarType val="both"/>
            <c:errValType val="cust"/>
            <c:noEndCap val="0"/>
            <c:plus>
              <c:numRef>
                <c:f>'Triplicates '!$M$6:$M$9</c:f>
                <c:numCache>
                  <c:formatCode>General</c:formatCode>
                  <c:ptCount val="4"/>
                  <c:pt idx="0">
                    <c:v>8.8734372358400607E-2</c:v>
                  </c:pt>
                  <c:pt idx="1">
                    <c:v>8.6317964097335442E-2</c:v>
                  </c:pt>
                  <c:pt idx="2">
                    <c:v>3.4721180858133055E-2</c:v>
                  </c:pt>
                  <c:pt idx="3">
                    <c:v>0.61461114760216706</c:v>
                  </c:pt>
                </c:numCache>
              </c:numRef>
            </c:plus>
            <c:minus>
              <c:numRef>
                <c:f>'Triplicates '!$M$6:$M$9</c:f>
                <c:numCache>
                  <c:formatCode>General</c:formatCode>
                  <c:ptCount val="4"/>
                  <c:pt idx="0">
                    <c:v>8.8734372358400607E-2</c:v>
                  </c:pt>
                  <c:pt idx="1">
                    <c:v>8.6317964097335442E-2</c:v>
                  </c:pt>
                  <c:pt idx="2">
                    <c:v>3.4721180858133055E-2</c:v>
                  </c:pt>
                  <c:pt idx="3">
                    <c:v>0.61461114760216706</c:v>
                  </c:pt>
                </c:numCache>
              </c:numRef>
            </c:minus>
          </c:errBars>
          <c:cat>
            <c:numRef>
              <c:f>'Triplicates '!$U$5:$U$8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</c:numCache>
            </c:numRef>
          </c:cat>
          <c:val>
            <c:numRef>
              <c:f>'Triplicates '!$L$6:$L$9</c:f>
              <c:numCache>
                <c:formatCode>General</c:formatCode>
                <c:ptCount val="4"/>
                <c:pt idx="0">
                  <c:v>0.53719006369607114</c:v>
                </c:pt>
                <c:pt idx="1">
                  <c:v>0.36391090419962541</c:v>
                </c:pt>
                <c:pt idx="2">
                  <c:v>0.48336733837667872</c:v>
                </c:pt>
                <c:pt idx="3">
                  <c:v>1.83907617838133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9341824"/>
        <c:axId val="119343744"/>
      </c:barChart>
      <c:scatterChart>
        <c:scatterStyle val="lineMarker"/>
        <c:varyColors val="0"/>
        <c:ser>
          <c:idx val="2"/>
          <c:order val="3"/>
          <c:tx>
            <c:v>% RPD</c:v>
          </c:tx>
          <c:spPr>
            <a:ln w="28575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x"/>
            <c:size val="7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Triplicates '!$AA$5:$AA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6.5263379469398322</c:v>
                  </c:pt>
                  <c:pt idx="2">
                    <c:v>3.9786365431183701</c:v>
                  </c:pt>
                  <c:pt idx="3">
                    <c:v>12.347870851444034</c:v>
                  </c:pt>
                  <c:pt idx="4">
                    <c:v>5.8837746076398885</c:v>
                  </c:pt>
                </c:numCache>
              </c:numRef>
            </c:plus>
            <c:minus>
              <c:numRef>
                <c:f>'Triplicates '!$AA$5:$AA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6.5263379469398322</c:v>
                  </c:pt>
                  <c:pt idx="2">
                    <c:v>3.9786365431183701</c:v>
                  </c:pt>
                  <c:pt idx="3">
                    <c:v>12.347870851444034</c:v>
                  </c:pt>
                  <c:pt idx="4">
                    <c:v>5.8837746076398885</c:v>
                  </c:pt>
                </c:numCache>
              </c:numRef>
            </c:minus>
          </c:errBars>
          <c:yVal>
            <c:numRef>
              <c:f>'Triplicates '!$Z$5:$Z$8</c:f>
              <c:numCache>
                <c:formatCode>General</c:formatCode>
                <c:ptCount val="4"/>
                <c:pt idx="0">
                  <c:v>100</c:v>
                </c:pt>
                <c:pt idx="1">
                  <c:v>97.233870322228057</c:v>
                </c:pt>
                <c:pt idx="2">
                  <c:v>96.22495077667817</c:v>
                </c:pt>
                <c:pt idx="3">
                  <c:v>64.82300791679283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351936"/>
        <c:axId val="119350016"/>
      </c:scatterChart>
      <c:catAx>
        <c:axId val="1193418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OTA (µg/ml)</a:t>
                </a:r>
              </a:p>
            </c:rich>
          </c:tx>
          <c:layout>
            <c:manualLayout>
              <c:xMode val="edge"/>
              <c:yMode val="edge"/>
              <c:x val="0.36529317632850233"/>
              <c:y val="0.941862987987987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19343744"/>
        <c:crosses val="autoZero"/>
        <c:auto val="1"/>
        <c:lblAlgn val="ctr"/>
        <c:lblOffset val="100"/>
        <c:noMultiLvlLbl val="0"/>
      </c:catAx>
      <c:valAx>
        <c:axId val="119343744"/>
        <c:scaling>
          <c:orientation val="minMax"/>
          <c:max val="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% Micronuclei</a:t>
                </a:r>
              </a:p>
            </c:rich>
          </c:tx>
          <c:layout>
            <c:manualLayout>
              <c:xMode val="edge"/>
              <c:yMode val="edge"/>
              <c:x val="6.5733695652173893E-3"/>
              <c:y val="0.3472653903903903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19341824"/>
        <c:crosses val="autoZero"/>
        <c:crossBetween val="between"/>
        <c:majorUnit val="1"/>
      </c:valAx>
      <c:valAx>
        <c:axId val="119350016"/>
        <c:scaling>
          <c:orientation val="minMax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dirty="0"/>
                  <a:t>% </a:t>
                </a:r>
                <a:r>
                  <a:rPr lang="en-GB" dirty="0" smtClean="0"/>
                  <a:t>Relative Population Doubling</a:t>
                </a:r>
                <a:endParaRPr lang="en-GB" dirty="0"/>
              </a:p>
            </c:rich>
          </c:tx>
          <c:layout>
            <c:manualLayout>
              <c:xMode val="edge"/>
              <c:yMode val="edge"/>
              <c:x val="0.93726298309178746"/>
              <c:y val="0.211231981981981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95000"/>
                <a:lumOff val="5000"/>
              </a:schemeClr>
            </a:solidFill>
          </a:ln>
        </c:spPr>
        <c:crossAx val="119351936"/>
        <c:crosses val="max"/>
        <c:crossBetween val="between"/>
      </c:valAx>
      <c:catAx>
        <c:axId val="119351936"/>
        <c:scaling>
          <c:orientation val="minMax"/>
        </c:scaling>
        <c:delete val="1"/>
        <c:axPos val="b"/>
        <c:majorTickMark val="out"/>
        <c:minorTickMark val="none"/>
        <c:tickLblPos val="nextTo"/>
        <c:crossAx val="119350016"/>
        <c:crosses val="autoZero"/>
        <c:auto val="1"/>
        <c:lblAlgn val="ctr"/>
        <c:lblOffset val="100"/>
        <c:noMultiLvlLbl val="1"/>
      </c:catAx>
    </c:plotArea>
    <c:legend>
      <c:legendPos val="t"/>
      <c:layout>
        <c:manualLayout>
          <c:xMode val="edge"/>
          <c:yMode val="edge"/>
          <c:x val="8.8967925619467064E-2"/>
          <c:y val="2.2408963585434174E-2"/>
          <c:w val="0.86726188887406008"/>
          <c:h val="0.12947087496415891"/>
        </c:manualLayout>
      </c:layout>
      <c:overlay val="0"/>
    </c:legend>
    <c:plotVisOnly val="1"/>
    <c:dispBlanksAs val="gap"/>
    <c:showDLblsOverMax val="0"/>
  </c:chart>
  <c:spPr>
    <a:ln>
      <a:solidFill>
        <a:schemeClr val="tx1">
          <a:lumMod val="95000"/>
          <a:lumOff val="5000"/>
        </a:schemeClr>
      </a:solidFill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4797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4427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166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0272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6257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3004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8066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4496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53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51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277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6A8AC8-D36B-4DBD-8D3C-BF1B34A50FFD}" type="datetimeFigureOut">
              <a:rPr lang="en-GB" smtClean="0"/>
              <a:t>02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DCB09-85EC-4B24-AE36-454D422A59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2735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3331535"/>
              </p:ext>
            </p:extLst>
          </p:nvPr>
        </p:nvGraphicFramePr>
        <p:xfrm>
          <a:off x="539552" y="260648"/>
          <a:ext cx="3311277" cy="2663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6994267"/>
              </p:ext>
            </p:extLst>
          </p:nvPr>
        </p:nvGraphicFramePr>
        <p:xfrm>
          <a:off x="4932040" y="282112"/>
          <a:ext cx="3312000" cy="266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3417808"/>
              </p:ext>
            </p:extLst>
          </p:nvPr>
        </p:nvGraphicFramePr>
        <p:xfrm>
          <a:off x="3059832" y="3185335"/>
          <a:ext cx="3312000" cy="266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31032" y="5959579"/>
            <a:ext cx="871296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Figure 6</a:t>
            </a:r>
            <a:r>
              <a:rPr lang="en-GB" sz="1100" dirty="0" smtClean="0"/>
              <a:t>  MN responses in the </a:t>
            </a:r>
            <a:r>
              <a:rPr lang="en-GB" sz="1100" i="1" dirty="0" smtClean="0"/>
              <a:t>in vitro </a:t>
            </a:r>
            <a:r>
              <a:rPr lang="en-GB" sz="1100" dirty="0" smtClean="0"/>
              <a:t>MN assay (with and without cyto-B) for </a:t>
            </a:r>
            <a:r>
              <a:rPr lang="en-GB" sz="1100" dirty="0"/>
              <a:t>MMS, Carbendazim and OTA in TK6 cells following </a:t>
            </a:r>
            <a:r>
              <a:rPr lang="en-GB" sz="1100" dirty="0" smtClean="0"/>
              <a:t>30 hrs treatment  </a:t>
            </a:r>
            <a:r>
              <a:rPr lang="en-GB" sz="1100" dirty="0"/>
              <a:t>The mean MN frequencies derived </a:t>
            </a:r>
            <a:r>
              <a:rPr lang="en-GB" sz="1100" dirty="0" smtClean="0"/>
              <a:t>in the absence of cyto-B by </a:t>
            </a:r>
            <a:r>
              <a:rPr lang="en-GB" sz="1100" dirty="0"/>
              <a:t>the MicroFlow (black bars) approach </a:t>
            </a:r>
            <a:r>
              <a:rPr lang="en-GB" sz="1100" dirty="0" smtClean="0"/>
              <a:t>and </a:t>
            </a:r>
            <a:r>
              <a:rPr lang="en-GB" sz="1100" dirty="0"/>
              <a:t>the Metafer (grey bars) scoring </a:t>
            </a:r>
            <a:r>
              <a:rPr lang="en-GB" sz="1100" dirty="0" smtClean="0"/>
              <a:t>platforms. The green bars to represent the mean MN frequencies derived in the presence of cyto-B (CBMN assay) using the Metafer platform. </a:t>
            </a:r>
            <a:r>
              <a:rPr lang="en-GB" sz="1100" dirty="0"/>
              <a:t>* indicates a significant increase in the MN formation over the control using a (p&lt;0.05).  Error bars represent mean </a:t>
            </a:r>
            <a:r>
              <a:rPr lang="en-GB" sz="1100" u="sng" dirty="0"/>
              <a:t>+</a:t>
            </a:r>
            <a:r>
              <a:rPr lang="en-GB" sz="1100" dirty="0"/>
              <a:t> SD (n=3). The %RPD values in these graphs are same as those seen in the figure 1.</a:t>
            </a:r>
          </a:p>
        </p:txBody>
      </p:sp>
    </p:spTree>
    <p:extLst>
      <p:ext uri="{BB962C8B-B14F-4D97-AF65-F5344CB8AC3E}">
        <p14:creationId xmlns:p14="http://schemas.microsoft.com/office/powerpoint/2010/main" val="23093792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8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wanse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ma J.R.</dc:creator>
  <cp:lastModifiedBy>Verma J.R.</cp:lastModifiedBy>
  <cp:revision>1</cp:revision>
  <dcterms:created xsi:type="dcterms:W3CDTF">2016-12-02T10:11:50Z</dcterms:created>
  <dcterms:modified xsi:type="dcterms:W3CDTF">2016-12-02T10:13:12Z</dcterms:modified>
</cp:coreProperties>
</file>